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E9B80-33E5-4D2C-973C-E639B492A2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38ABD-C78B-4A09-9CB4-ED186FCE36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35709-0734-432D-8DE1-377AE3C1EA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9B7E5-84B9-4477-8017-4446805CFF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E5189-86B8-41B8-B7D2-F4172B0B47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B43A2-CC56-4CE8-BEC4-DBAD87273D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C973C-E849-4EDA-8814-2463F6EBB6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1E120-E0FB-4095-A262-72800A40C2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86FA3-C035-4615-B591-09D9792039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DED69-21C4-450A-B92C-B042915D8E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C3A71-88F2-438F-8D91-0A469F50DA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CF564-A0AD-47BF-AF99-81C5BA18E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245280"/>
            <a:ext cx="2131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  <a:ea typeface="DejaVu San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5280"/>
            <a:ext cx="289404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  <a:ea typeface="DejaVu San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  <a:ea typeface="DejaVu San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5FEA681C-9ABA-4BC3-9F5D-4F905398F334}" type="slidenum">
              <a:rPr b="0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66680" y="887400"/>
          <a:ext cx="7283520" cy="18334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66680" y="887400"/>
                    <a:ext cx="7283520" cy="183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1173240" y="3040200"/>
          <a:ext cx="7176960" cy="16858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73240" y="3040200"/>
                    <a:ext cx="7176960" cy="1685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1042920" y="4629240"/>
          <a:ext cx="7299360" cy="20127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042920" y="4629240"/>
                    <a:ext cx="7299360" cy="2012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 rot="16200000">
            <a:off x="1842840" y="726840"/>
            <a:ext cx="177840" cy="469800"/>
          </a:xfrm>
          <a:custGeom>
            <a:avLst/>
            <a:gdLst>
              <a:gd name="textAreaLeft" fmla="*/ 0 w 177840"/>
              <a:gd name="textAreaRight" fmla="*/ 64080 w 177840"/>
              <a:gd name="textAreaTop" fmla="*/ 12240 h 469800"/>
              <a:gd name="textAreaBottom" fmla="*/ 457560 h 469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547640" y="549360"/>
            <a:ext cx="7207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Alge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2668320" y="379080"/>
            <a:ext cx="177840" cy="1149480"/>
          </a:xfrm>
          <a:custGeom>
            <a:avLst/>
            <a:gdLst>
              <a:gd name="textAreaLeft" fmla="*/ 0 w 177840"/>
              <a:gd name="textAreaRight" fmla="*/ 64080 w 177840"/>
              <a:gd name="textAreaTop" fmla="*/ 29880 h 1149480"/>
              <a:gd name="textAreaBottom" fmla="*/ 1119600 h 1149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48000" y="333360"/>
            <a:ext cx="1150920" cy="289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South-East of Euro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050920" y="189000"/>
            <a:ext cx="136872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East of the Mediterranean Bas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3791520" y="521280"/>
            <a:ext cx="179280" cy="809640"/>
          </a:xfrm>
          <a:custGeom>
            <a:avLst/>
            <a:gdLst>
              <a:gd name="textAreaLeft" fmla="*/ 0 w 179280"/>
              <a:gd name="textAreaRight" fmla="*/ 64800 w 179280"/>
              <a:gd name="textAreaTop" fmla="*/ 20880 h 809640"/>
              <a:gd name="textAreaBottom" fmla="*/ 788760 h 809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4346280" y="792000"/>
            <a:ext cx="177840" cy="250920"/>
          </a:xfrm>
          <a:custGeom>
            <a:avLst/>
            <a:gdLst>
              <a:gd name="textAreaLeft" fmla="*/ 0 w 177840"/>
              <a:gd name="textAreaRight" fmla="*/ 64080 w 177840"/>
              <a:gd name="textAreaTop" fmla="*/ 6480 h 250920"/>
              <a:gd name="textAreaBottom" fmla="*/ 244440 h 250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4759920" y="639000"/>
            <a:ext cx="177840" cy="541080"/>
          </a:xfrm>
          <a:custGeom>
            <a:avLst/>
            <a:gdLst>
              <a:gd name="textAreaLeft" fmla="*/ 0 w 177840"/>
              <a:gd name="textAreaRight" fmla="*/ 64080 w 177840"/>
              <a:gd name="textAreaTop" fmla="*/ 14040 h 541080"/>
              <a:gd name="textAreaBottom" fmla="*/ 527040 h 541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067280" y="608040"/>
            <a:ext cx="792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unis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87640" y="620640"/>
            <a:ext cx="93672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Morocc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467240" y="476280"/>
            <a:ext cx="896760" cy="27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Alge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5875920" y="64080"/>
            <a:ext cx="177840" cy="1690920"/>
          </a:xfrm>
          <a:custGeom>
            <a:avLst/>
            <a:gdLst>
              <a:gd name="textAreaLeft" fmla="*/ 0 w 177840"/>
              <a:gd name="textAreaRight" fmla="*/ 64080 w 177840"/>
              <a:gd name="textAreaTop" fmla="*/ 43920 h 1690920"/>
              <a:gd name="textAreaBottom" fmla="*/ 1647000 h 1690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7012080" y="612720"/>
            <a:ext cx="179280" cy="582480"/>
          </a:xfrm>
          <a:custGeom>
            <a:avLst/>
            <a:gdLst>
              <a:gd name="textAreaLeft" fmla="*/ 0 w 179280"/>
              <a:gd name="textAreaRight" fmla="*/ 64800 w 179280"/>
              <a:gd name="textAreaTop" fmla="*/ 15120 h 582480"/>
              <a:gd name="textAreaBottom" fmla="*/ 567360 h 582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7551000" y="681840"/>
            <a:ext cx="179280" cy="444240"/>
          </a:xfrm>
          <a:custGeom>
            <a:avLst/>
            <a:gdLst>
              <a:gd name="textAreaLeft" fmla="*/ 0 w 179280"/>
              <a:gd name="textAreaRight" fmla="*/ 64800 w 179280"/>
              <a:gd name="textAreaTop" fmla="*/ 11520 h 444240"/>
              <a:gd name="textAreaBottom" fmla="*/ 432720 h 444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7971840" y="729360"/>
            <a:ext cx="179280" cy="349200"/>
          </a:xfrm>
          <a:custGeom>
            <a:avLst/>
            <a:gdLst>
              <a:gd name="textAreaLeft" fmla="*/ 0 w 179280"/>
              <a:gd name="textAreaRight" fmla="*/ 64800 w 179280"/>
              <a:gd name="textAreaTop" fmla="*/ 9000 h 349200"/>
              <a:gd name="textAreaBottom" fmla="*/ 340200 h 349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508720" y="54936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Sp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659640" y="549360"/>
            <a:ext cx="93672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Morocc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164360" y="333360"/>
            <a:ext cx="86364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rtug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667640" y="549360"/>
            <a:ext cx="79200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3021120" y="1325160"/>
            <a:ext cx="191880" cy="2840040"/>
          </a:xfrm>
          <a:custGeom>
            <a:avLst/>
            <a:gdLst>
              <a:gd name="textAreaLeft" fmla="*/ 122760 w 191880"/>
              <a:gd name="textAreaRight" fmla="*/ 192240 w 191880"/>
              <a:gd name="textAreaTop" fmla="*/ 73800 h 2840040"/>
              <a:gd name="textAreaBottom" fmla="*/ 2766240 h 2840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411280" y="2847960"/>
            <a:ext cx="135252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Groupe1 SS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6293520" y="897480"/>
            <a:ext cx="193680" cy="3706920"/>
          </a:xfrm>
          <a:custGeom>
            <a:avLst/>
            <a:gdLst>
              <a:gd name="textAreaLeft" fmla="*/ 123840 w 193680"/>
              <a:gd name="textAreaRight" fmla="*/ 194040 w 193680"/>
              <a:gd name="textAreaTop" fmla="*/ 96480 h 3706920"/>
              <a:gd name="textAreaBottom" fmla="*/ 3610440 h 3706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711760" y="2855880"/>
            <a:ext cx="134316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66ff33"/>
                </a:solidFill>
                <a:latin typeface="Arial"/>
              </a:rPr>
              <a:t>Groupe2 SS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3320280" y="896040"/>
            <a:ext cx="163440" cy="120960"/>
          </a:xfrm>
          <a:custGeom>
            <a:avLst/>
            <a:gdLst>
              <a:gd name="textAreaLeft" fmla="*/ 0 w 163440"/>
              <a:gd name="textAreaRight" fmla="*/ 59040 w 163440"/>
              <a:gd name="textAreaTop" fmla="*/ 2880 h 120960"/>
              <a:gd name="textAreaBottom" fmla="*/ 118080 h 120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1478520" y="840240"/>
            <a:ext cx="177840" cy="243000"/>
          </a:xfrm>
          <a:custGeom>
            <a:avLst/>
            <a:gdLst>
              <a:gd name="textAreaLeft" fmla="*/ 0 w 177840"/>
              <a:gd name="textAreaRight" fmla="*/ 64080 w 177840"/>
              <a:gd name="textAreaTop" fmla="*/ 6120 h 243000"/>
              <a:gd name="textAreaBottom" fmla="*/ 236880 h 243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332000" y="620640"/>
            <a:ext cx="503280" cy="31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*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95280" y="1125360"/>
            <a:ext cx="9050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=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95280" y="4869000"/>
            <a:ext cx="9050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=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95280" y="3284640"/>
            <a:ext cx="9050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=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5T14:09:23Z</dcterms:created>
  <dc:creator>Ronfort</dc:creator>
  <dc:description/>
  <dc:language>en-US</dc:language>
  <cp:lastModifiedBy>Ronfort</cp:lastModifiedBy>
  <dcterms:modified xsi:type="dcterms:W3CDTF">2010-11-05T14:12:44Z</dcterms:modified>
  <cp:revision>3</cp:revision>
  <dc:subject/>
  <dc:title>Diapositive 1</dc:title>
</cp:coreProperties>
</file>